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3238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0016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32005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73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31892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75074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1981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48590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10067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30112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53922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171D4-B9DB-4681-BED9-F21FF4EFA37C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FF27A-2FD1-48D8-A4DA-23DB80D4673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48058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uadroTexto 14"/>
          <p:cNvSpPr txBox="1"/>
          <p:nvPr/>
        </p:nvSpPr>
        <p:spPr>
          <a:xfrm>
            <a:off x="8640418" y="99395"/>
            <a:ext cx="536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B1</a:t>
            </a:r>
            <a:endParaRPr lang="es-MX" sz="2400" b="1" dirty="0"/>
          </a:p>
        </p:txBody>
      </p:sp>
      <p:sp>
        <p:nvSpPr>
          <p:cNvPr id="17" name="CuadroTexto 16"/>
          <p:cNvSpPr txBox="1"/>
          <p:nvPr/>
        </p:nvSpPr>
        <p:spPr>
          <a:xfrm>
            <a:off x="4234072" y="3452195"/>
            <a:ext cx="59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>
                <a:solidFill>
                  <a:schemeClr val="bg1"/>
                </a:solidFill>
              </a:rPr>
              <a:t>A2</a:t>
            </a:r>
            <a:endParaRPr lang="es-MX" sz="2400" b="1" dirty="0">
              <a:solidFill>
                <a:schemeClr val="bg1"/>
              </a:solidFill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8647046" y="3445571"/>
            <a:ext cx="536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B2</a:t>
            </a:r>
            <a:endParaRPr lang="es-MX" sz="2400" b="1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416" y="120512"/>
            <a:ext cx="4585873" cy="3331876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3532" y="3457906"/>
            <a:ext cx="4396490" cy="3261130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3523" y="120512"/>
            <a:ext cx="4391569" cy="3355565"/>
          </a:xfrm>
          <a:prstGeom prst="rect">
            <a:avLst/>
          </a:prstGeom>
        </p:spPr>
      </p:pic>
      <p:cxnSp>
        <p:nvCxnSpPr>
          <p:cNvPr id="13" name="Conector recto de flecha 12"/>
          <p:cNvCxnSpPr/>
          <p:nvPr/>
        </p:nvCxnSpPr>
        <p:spPr>
          <a:xfrm flipH="1">
            <a:off x="11960101" y="4472607"/>
            <a:ext cx="384313" cy="34455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13"/>
          <p:cNvSpPr txBox="1"/>
          <p:nvPr/>
        </p:nvSpPr>
        <p:spPr>
          <a:xfrm>
            <a:off x="4227444" y="106019"/>
            <a:ext cx="59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A1</a:t>
            </a:r>
            <a:endParaRPr lang="es-MX" sz="2400" b="1" dirty="0"/>
          </a:p>
        </p:txBody>
      </p:sp>
      <p:sp>
        <p:nvSpPr>
          <p:cNvPr id="16" name="CuadroTexto 15"/>
          <p:cNvSpPr txBox="1"/>
          <p:nvPr/>
        </p:nvSpPr>
        <p:spPr>
          <a:xfrm>
            <a:off x="13026889" y="125899"/>
            <a:ext cx="5234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C1</a:t>
            </a:r>
            <a:endParaRPr lang="es-MX" sz="2400" b="1" dirty="0"/>
          </a:p>
        </p:txBody>
      </p:sp>
      <p:sp>
        <p:nvSpPr>
          <p:cNvPr id="19" name="CuadroTexto 18"/>
          <p:cNvSpPr txBox="1"/>
          <p:nvPr/>
        </p:nvSpPr>
        <p:spPr>
          <a:xfrm>
            <a:off x="13033517" y="3472075"/>
            <a:ext cx="5234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C2</a:t>
            </a:r>
            <a:endParaRPr lang="es-MX" sz="2400" b="1" dirty="0"/>
          </a:p>
        </p:txBody>
      </p:sp>
      <p:pic>
        <p:nvPicPr>
          <p:cNvPr id="21" name="Imagen 2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5744" y="3430583"/>
            <a:ext cx="4447776" cy="3288453"/>
          </a:xfrm>
          <a:prstGeom prst="rect">
            <a:avLst/>
          </a:prstGeom>
        </p:spPr>
      </p:pic>
      <p:cxnSp>
        <p:nvCxnSpPr>
          <p:cNvPr id="22" name="Conector recto de flecha 21"/>
          <p:cNvCxnSpPr/>
          <p:nvPr/>
        </p:nvCxnSpPr>
        <p:spPr>
          <a:xfrm flipH="1">
            <a:off x="8004320" y="4166077"/>
            <a:ext cx="384313" cy="34455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de flecha 22"/>
          <p:cNvCxnSpPr/>
          <p:nvPr/>
        </p:nvCxnSpPr>
        <p:spPr>
          <a:xfrm flipH="1">
            <a:off x="7215811" y="3993797"/>
            <a:ext cx="258419" cy="52346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Imagen 2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7296" y="112647"/>
            <a:ext cx="4426224" cy="3317936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486" y="3456196"/>
            <a:ext cx="4577555" cy="3238333"/>
          </a:xfrm>
          <a:prstGeom prst="rect">
            <a:avLst/>
          </a:prstGeom>
        </p:spPr>
      </p:pic>
      <p:sp>
        <p:nvSpPr>
          <p:cNvPr id="26" name="CuadroTexto 25"/>
          <p:cNvSpPr txBox="1"/>
          <p:nvPr/>
        </p:nvSpPr>
        <p:spPr>
          <a:xfrm>
            <a:off x="8633795" y="112647"/>
            <a:ext cx="59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/>
              <a:t>B</a:t>
            </a:r>
            <a:r>
              <a:rPr lang="es-MX" sz="2400" b="1" dirty="0" smtClean="0"/>
              <a:t>1</a:t>
            </a:r>
            <a:endParaRPr lang="es-MX" sz="2400" b="1" dirty="0"/>
          </a:p>
        </p:txBody>
      </p:sp>
      <p:sp>
        <p:nvSpPr>
          <p:cNvPr id="27" name="CuadroTexto 26"/>
          <p:cNvSpPr txBox="1"/>
          <p:nvPr/>
        </p:nvSpPr>
        <p:spPr>
          <a:xfrm>
            <a:off x="4234072" y="3452194"/>
            <a:ext cx="59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>
                <a:solidFill>
                  <a:schemeClr val="bg1"/>
                </a:solidFill>
              </a:rPr>
              <a:t>A2</a:t>
            </a:r>
            <a:endParaRPr lang="es-MX" sz="2400" b="1" dirty="0">
              <a:solidFill>
                <a:schemeClr val="bg1"/>
              </a:solidFill>
            </a:endParaRPr>
          </a:p>
        </p:txBody>
      </p:sp>
      <p:sp>
        <p:nvSpPr>
          <p:cNvPr id="28" name="CuadroTexto 27"/>
          <p:cNvSpPr txBox="1"/>
          <p:nvPr/>
        </p:nvSpPr>
        <p:spPr>
          <a:xfrm>
            <a:off x="8653675" y="3445573"/>
            <a:ext cx="59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b="1" dirty="0" smtClean="0"/>
              <a:t>B</a:t>
            </a:r>
            <a:r>
              <a:rPr lang="es-MX" sz="2400" b="1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675637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993912" y="1404726"/>
            <a:ext cx="10654747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s-MX" sz="16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ppl</a:t>
            </a:r>
            <a:r>
              <a:rPr lang="es-MX" sz="16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4. </a:t>
            </a:r>
            <a:r>
              <a:rPr lang="es-MX" sz="16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orphological</a:t>
            </a:r>
            <a:r>
              <a:rPr lang="es-MX" sz="16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eatures</a:t>
            </a:r>
            <a:r>
              <a:rPr lang="es-MX" sz="16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eratopogonida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A1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emal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uren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reshly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ed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; A2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ng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uren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lack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rrow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hows distal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hit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cule in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ell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3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thout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otch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red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rrow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ndicat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orsal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acrotrichia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 r3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ein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500 µm); B1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ult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nsigni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1 mm); B2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ng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nsigni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ed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rrow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tension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h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igmented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3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ein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lack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rrow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ell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3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th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 distal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hit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cule)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500 µm); C1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ult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egni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C2: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ng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es-MX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s-MX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egnis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single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aint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acrotrichium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econd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adial 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ell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</a:t>
            </a:r>
            <a:r>
              <a:rPr lang="es-MX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es-MX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500 µm</a:t>
            </a:r>
            <a:r>
              <a:rPr lang="es-MX" sz="16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 [44, 45]. </a:t>
            </a:r>
            <a:endParaRPr lang="es-MX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9579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6</Words>
  <Application>Microsoft Office PowerPoint</Application>
  <PresentationFormat>Panorámica</PresentationFormat>
  <Paragraphs>10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José Ríos Tostado</dc:creator>
  <cp:lastModifiedBy>Juan José Ríos Tostado</cp:lastModifiedBy>
  <cp:revision>1</cp:revision>
  <dcterms:created xsi:type="dcterms:W3CDTF">2026-06-03T03:04:42Z</dcterms:created>
  <dcterms:modified xsi:type="dcterms:W3CDTF">2026-06-03T03:07:28Z</dcterms:modified>
</cp:coreProperties>
</file>